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8686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97" userDrawn="1">
          <p15:clr>
            <a:srgbClr val="A4A3A4"/>
          </p15:clr>
        </p15:guide>
        <p15:guide id="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530"/>
    <p:restoredTop sz="99783" autoAdjust="0"/>
  </p:normalViewPr>
  <p:slideViewPr>
    <p:cSldViewPr snapToGrid="0" snapToObjects="1" showGuides="1">
      <p:cViewPr varScale="1">
        <p:scale>
          <a:sx n="98" d="100"/>
          <a:sy n="98" d="100"/>
        </p:scale>
        <p:origin x="2320" y="192"/>
      </p:cViewPr>
      <p:guideLst>
        <p:guide orient="horz" pos="2797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051B62-D56B-2A49-B75E-4CDC46286272}" type="datetimeFigureOut">
              <a:rPr lang="en-US" smtClean="0"/>
              <a:t>3/28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04988" y="1143000"/>
            <a:ext cx="3248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841B69-ED92-284F-8C12-6C8D26C24E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2412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698545"/>
            <a:ext cx="7772400" cy="1862031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922520"/>
            <a:ext cx="6400800" cy="22199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8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2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0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790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398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47881"/>
            <a:ext cx="2057400" cy="741193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47881"/>
            <a:ext cx="6019800" cy="741193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402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724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582078"/>
            <a:ext cx="7772400" cy="172529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681844"/>
            <a:ext cx="7772400" cy="19002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884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76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649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532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415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297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18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064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179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026927"/>
            <a:ext cx="4038600" cy="5732886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026927"/>
            <a:ext cx="4038600" cy="5732886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798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944477"/>
            <a:ext cx="4040188" cy="81036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4" indent="0">
              <a:buNone/>
              <a:defRPr sz="1500" b="1"/>
            </a:lvl2pPr>
            <a:lvl3pPr marL="685767" indent="0">
              <a:buNone/>
              <a:defRPr sz="1350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5" indent="0">
              <a:buNone/>
              <a:defRPr sz="1200" b="1"/>
            </a:lvl6pPr>
            <a:lvl7pPr marL="2057297" indent="0">
              <a:buNone/>
              <a:defRPr sz="1200" b="1"/>
            </a:lvl7pPr>
            <a:lvl8pPr marL="2400180" indent="0">
              <a:buNone/>
              <a:defRPr sz="1200" b="1"/>
            </a:lvl8pPr>
            <a:lvl9pPr marL="274306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754841"/>
            <a:ext cx="4040188" cy="5004965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3" y="1944477"/>
            <a:ext cx="4041775" cy="81036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4" indent="0">
              <a:buNone/>
              <a:defRPr sz="1500" b="1"/>
            </a:lvl2pPr>
            <a:lvl3pPr marL="685767" indent="0">
              <a:buNone/>
              <a:defRPr sz="1350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5" indent="0">
              <a:buNone/>
              <a:defRPr sz="1200" b="1"/>
            </a:lvl6pPr>
            <a:lvl7pPr marL="2057297" indent="0">
              <a:buNone/>
              <a:defRPr sz="1200" b="1"/>
            </a:lvl7pPr>
            <a:lvl8pPr marL="2400180" indent="0">
              <a:buNone/>
              <a:defRPr sz="1200" b="1"/>
            </a:lvl8pPr>
            <a:lvl9pPr marL="274306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3" y="2754841"/>
            <a:ext cx="4041775" cy="5004965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941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412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671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7" y="345864"/>
            <a:ext cx="3008313" cy="147193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45870"/>
            <a:ext cx="5111750" cy="741394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7" y="1817801"/>
            <a:ext cx="3008313" cy="5942013"/>
          </a:xfrm>
        </p:spPr>
        <p:txBody>
          <a:bodyPr/>
          <a:lstStyle>
            <a:lvl1pPr marL="0" indent="0">
              <a:buNone/>
              <a:defRPr sz="1050"/>
            </a:lvl1pPr>
            <a:lvl2pPr marL="342884" indent="0">
              <a:buNone/>
              <a:defRPr sz="900"/>
            </a:lvl2pPr>
            <a:lvl3pPr marL="685767" indent="0">
              <a:buNone/>
              <a:defRPr sz="750"/>
            </a:lvl3pPr>
            <a:lvl4pPr marL="1028649" indent="0">
              <a:buNone/>
              <a:defRPr sz="675"/>
            </a:lvl4pPr>
            <a:lvl5pPr marL="1371532" indent="0">
              <a:buNone/>
              <a:defRPr sz="675"/>
            </a:lvl5pPr>
            <a:lvl6pPr marL="1714415" indent="0">
              <a:buNone/>
              <a:defRPr sz="675"/>
            </a:lvl6pPr>
            <a:lvl7pPr marL="2057297" indent="0">
              <a:buNone/>
              <a:defRPr sz="675"/>
            </a:lvl7pPr>
            <a:lvl8pPr marL="2400180" indent="0">
              <a:buNone/>
              <a:defRPr sz="675"/>
            </a:lvl8pPr>
            <a:lvl9pPr marL="2743064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769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6080762"/>
            <a:ext cx="5486400" cy="717869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776182"/>
            <a:ext cx="5486400" cy="5212080"/>
          </a:xfrm>
        </p:spPr>
        <p:txBody>
          <a:bodyPr/>
          <a:lstStyle>
            <a:lvl1pPr marL="0" indent="0">
              <a:buNone/>
              <a:defRPr sz="2400"/>
            </a:lvl1pPr>
            <a:lvl2pPr marL="342884" indent="0">
              <a:buNone/>
              <a:defRPr sz="2100"/>
            </a:lvl2pPr>
            <a:lvl3pPr marL="685767" indent="0">
              <a:buNone/>
              <a:defRPr sz="1800"/>
            </a:lvl3pPr>
            <a:lvl4pPr marL="1028649" indent="0">
              <a:buNone/>
              <a:defRPr sz="1500"/>
            </a:lvl4pPr>
            <a:lvl5pPr marL="1371532" indent="0">
              <a:buNone/>
              <a:defRPr sz="1500"/>
            </a:lvl5pPr>
            <a:lvl6pPr marL="1714415" indent="0">
              <a:buNone/>
              <a:defRPr sz="1500"/>
            </a:lvl6pPr>
            <a:lvl7pPr marL="2057297" indent="0">
              <a:buNone/>
              <a:defRPr sz="1500"/>
            </a:lvl7pPr>
            <a:lvl8pPr marL="2400180" indent="0">
              <a:buNone/>
              <a:defRPr sz="1500"/>
            </a:lvl8pPr>
            <a:lvl9pPr marL="2743064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6798630"/>
            <a:ext cx="5486400" cy="1019491"/>
          </a:xfrm>
        </p:spPr>
        <p:txBody>
          <a:bodyPr/>
          <a:lstStyle>
            <a:lvl1pPr marL="0" indent="0">
              <a:buNone/>
              <a:defRPr sz="1050"/>
            </a:lvl1pPr>
            <a:lvl2pPr marL="342884" indent="0">
              <a:buNone/>
              <a:defRPr sz="900"/>
            </a:lvl2pPr>
            <a:lvl3pPr marL="685767" indent="0">
              <a:buNone/>
              <a:defRPr sz="750"/>
            </a:lvl3pPr>
            <a:lvl4pPr marL="1028649" indent="0">
              <a:buNone/>
              <a:defRPr sz="675"/>
            </a:lvl4pPr>
            <a:lvl5pPr marL="1371532" indent="0">
              <a:buNone/>
              <a:defRPr sz="675"/>
            </a:lvl5pPr>
            <a:lvl6pPr marL="1714415" indent="0">
              <a:buNone/>
              <a:defRPr sz="675"/>
            </a:lvl6pPr>
            <a:lvl7pPr marL="2057297" indent="0">
              <a:buNone/>
              <a:defRPr sz="675"/>
            </a:lvl7pPr>
            <a:lvl8pPr marL="2400180" indent="0">
              <a:buNone/>
              <a:defRPr sz="675"/>
            </a:lvl8pPr>
            <a:lvl9pPr marL="2743064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373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347874"/>
            <a:ext cx="8229600" cy="1447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026927"/>
            <a:ext cx="8229600" cy="57328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8051383"/>
            <a:ext cx="213360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7DE55-82CE-8B41-B35C-6C156F5A00FB}" type="datetimeFigureOut">
              <a:rPr lang="en-US" smtClean="0"/>
              <a:pPr/>
              <a:t>3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8051383"/>
            <a:ext cx="289560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8051383"/>
            <a:ext cx="213360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65927A-9691-194B-BBFF-14B7A279EE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645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884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62" indent="-257162" algn="l" defTabSz="342884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184" indent="-214302" algn="l" defTabSz="342884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07" indent="-171442" algn="l" defTabSz="342884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90" indent="-171442" algn="l" defTabSz="342884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73" indent="-171442" algn="l" defTabSz="342884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56" indent="-171442" algn="l" defTabSz="342884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39" indent="-171442" algn="l" defTabSz="342884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22" indent="-171442" algn="l" defTabSz="342884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05" indent="-171442" algn="l" defTabSz="342884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4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67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9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32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15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97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80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64" algn="l" defTabSz="3428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494" y="5297010"/>
            <a:ext cx="2305486" cy="2305486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7980" y="5272728"/>
            <a:ext cx="2329881" cy="2329881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4617" y="2905933"/>
            <a:ext cx="2348147" cy="2348147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7981" y="2905935"/>
            <a:ext cx="2329880" cy="2329880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494" y="2909960"/>
            <a:ext cx="2245720" cy="224572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5983" y="350854"/>
            <a:ext cx="2458099" cy="2458099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8214" y="347502"/>
            <a:ext cx="2461452" cy="246145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232" y="345861"/>
            <a:ext cx="2409982" cy="2409982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1061199" y="909415"/>
            <a:ext cx="2799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446250" y="909415"/>
            <a:ext cx="310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>
                <a:latin typeface="Helvetica"/>
                <a:cs typeface="Helvetica"/>
              </a:rPr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129939" y="3384267"/>
            <a:ext cx="3569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Helvetica"/>
                <a:cs typeface="Helvetica"/>
              </a:rPr>
              <a:t>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059591" y="909415"/>
            <a:ext cx="2909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Helvetica"/>
                <a:cs typeface="Helvetica"/>
              </a:rPr>
              <a:t>c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956510" y="3384267"/>
            <a:ext cx="2932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Helvetica"/>
                <a:cs typeface="Helvetica"/>
              </a:rPr>
              <a:t>f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446249" y="3384267"/>
            <a:ext cx="336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Helvetica"/>
                <a:cs typeface="Helvetica"/>
              </a:rPr>
              <a:t>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478053" y="5766587"/>
            <a:ext cx="3622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Helvetica"/>
                <a:cs typeface="Helvetica"/>
              </a:rPr>
              <a:t>h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188420" y="5798396"/>
            <a:ext cx="3463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Helvetica"/>
                <a:cs typeface="Helvetica"/>
              </a:rPr>
              <a:t>g</a:t>
            </a:r>
          </a:p>
        </p:txBody>
      </p:sp>
      <p:sp>
        <p:nvSpPr>
          <p:cNvPr id="27" name="テキスト ボックス 3"/>
          <p:cNvSpPr txBox="1"/>
          <p:nvPr/>
        </p:nvSpPr>
        <p:spPr>
          <a:xfrm>
            <a:off x="572494" y="7555860"/>
            <a:ext cx="71402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le-Quantile (QQ) plots from the GWAS sca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wns,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nic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ctness and shape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nicle exertion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carp color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me covering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 height,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istance to smut,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le sterility. </a:t>
            </a:r>
          </a:p>
        </p:txBody>
      </p:sp>
    </p:spTree>
    <p:extLst>
      <p:ext uri="{BB962C8B-B14F-4D97-AF65-F5344CB8AC3E}">
        <p14:creationId xmlns:p14="http://schemas.microsoft.com/office/powerpoint/2010/main" val="1403127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</TotalTime>
  <Words>72</Words>
  <Application>Microsoft Macintosh PowerPoint</Application>
  <PresentationFormat>Custom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Company>IBR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luneh Tamiru Oli</dc:creator>
  <cp:lastModifiedBy>Gezahegn Girma</cp:lastModifiedBy>
  <cp:revision>25</cp:revision>
  <cp:lastPrinted>2014-10-29T04:25:43Z</cp:lastPrinted>
  <dcterms:created xsi:type="dcterms:W3CDTF">2015-05-11T20:03:38Z</dcterms:created>
  <dcterms:modified xsi:type="dcterms:W3CDTF">2019-03-28T20:52:38Z</dcterms:modified>
</cp:coreProperties>
</file>